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>
      <p:cViewPr varScale="1">
        <p:scale>
          <a:sx n="124" d="100"/>
          <a:sy n="124" d="100"/>
        </p:scale>
        <p:origin x="6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EA04A0-797F-DAA1-1311-390F1B81EA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723318C-8F49-D126-B737-747101D221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5BA6F8-8989-140C-6873-A040CFA5C4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FA38F-F534-4D4F-B156-1FA2D068621E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2731CC-C6C2-A54B-70DD-40F850CCC2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5230C4-3301-2FA8-CA2F-4DA6EF4A6E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F80-B508-274D-BB49-ED415FA69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696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A7BF79-27DF-3817-8AE4-BB7277779C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8690E6-A331-10BA-8247-2E6EEEE3FA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BCD02C-454E-BA90-92D6-C1DDB3746C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FA38F-F534-4D4F-B156-1FA2D068621E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D0981A-85FC-3EBE-6665-6D6A174F73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A1A365-8710-A3A1-045C-119651969F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F80-B508-274D-BB49-ED415FA69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285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C9F8FC2-BC2F-B4CC-55C0-41FC19376A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37D10A-A571-9505-676B-E952A6E7D1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ED4ED4-E2DC-D38D-23EC-60F37333CA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FA38F-F534-4D4F-B156-1FA2D068621E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031185-D2A6-20E5-0B96-03F4303A36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618FB-FCA5-19FE-B69E-30A12C2FA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F80-B508-274D-BB49-ED415FA69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1748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261DE9-0BDE-2EAB-538B-9B5829651C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BC05FA-2144-EB71-7AA6-2A545CF58D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F35706-2A36-503D-8793-6A22576B2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FA38F-F534-4D4F-B156-1FA2D068621E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B0DB97-05E6-40BC-5955-862810B96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506511-29B1-5311-D893-AC272C06D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F80-B508-274D-BB49-ED415FA69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029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839BA4-A834-5AD7-E6CD-7990EBFCEA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16C335-6D9E-D4EC-66AE-0CDEE2189E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FF5BD1-EA22-8BD9-A572-314C7CDF0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FA38F-F534-4D4F-B156-1FA2D068621E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BFD621-32F1-CCA5-EF83-9E8A58644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8EC544-EEC0-D08B-67D0-CA6C6D8BD9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F80-B508-274D-BB49-ED415FA69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892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273D22-FAD8-D593-7DE3-61BB9CAAB2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BB620E-2B7D-93DE-FF41-2660E219B0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0E9B14-A9E5-85BB-5A58-7309FCD308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18E9C6-9913-5D4F-0FA5-D6B588707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FA38F-F534-4D4F-B156-1FA2D068621E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B4A296-CFBE-A890-C1AF-D3A3DCF0D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BD2887D-E736-C97E-78F5-88B934E80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F80-B508-274D-BB49-ED415FA69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3637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633FC6-0CDC-4312-F82A-7852EB9CC7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DE635D-35EA-EF48-8270-50B8C2909C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A251A5-2ABA-4736-5238-E75DC74F9E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C300BFA-B5C1-5711-FAFE-14F19D0835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8D8162-58B1-5FD6-3DE9-48064B28845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1CD03B0-BD40-CEBD-4380-9ED0AE2BD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FA38F-F534-4D4F-B156-1FA2D068621E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C05572C-EA40-2667-D452-65D784F0CC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3905CCC-4387-1869-D515-3CD606D99F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F80-B508-274D-BB49-ED415FA69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1164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0A1AD4-4A3C-6012-68E1-132925093D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564E0E0-F7F2-BBC0-8408-8C2651E674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FA38F-F534-4D4F-B156-1FA2D068621E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64563A7-29BE-2F57-A3CE-181FECE3F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E75CC82-4203-16DF-34D8-D626A31BE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F80-B508-274D-BB49-ED415FA69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9237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B9321CA-2B6A-FF75-4733-EA5E89D7A7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FA38F-F534-4D4F-B156-1FA2D068621E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ED5AAF0-1CBC-DC48-302B-232F454A3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3D72EBD-EE85-19EC-A3EF-DC08F87957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F80-B508-274D-BB49-ED415FA69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648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5BA877-B7A6-1322-423C-5CCD43F32F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70BC2F-C2C2-2BBE-D92C-926EA645FC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E5B725-7829-C3E0-4C36-77A6420A0F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24ACEA-5DCD-DC80-581D-9069EB8DC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FA38F-F534-4D4F-B156-1FA2D068621E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CE89D5-12D3-3D7E-DE46-340F683096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7EFEA1-9A34-DD15-3F69-F6CDBA13F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F80-B508-274D-BB49-ED415FA69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064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B644AF-2DE7-3AA7-D2D9-C270795285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0AB88D8-586B-0BF6-4918-B611F01AA8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385F21E-0C49-BE2F-7351-B8196EF8EF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BCBB13-57DB-07A5-925A-D3CB0F8D99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2FA38F-F534-4D4F-B156-1FA2D068621E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A7675C-A71B-E216-4F70-4FAFF08BFA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A51064-944C-B758-92A1-17712FC87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CB6F80-B508-274D-BB49-ED415FA69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3893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567F2C2-EFB5-A53B-AADC-5B3B2E67E9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B4D24D-628B-F1EC-86FE-579991892D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978937-50C6-BB3C-3691-685D48CB26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2FA38F-F534-4D4F-B156-1FA2D068621E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EBC3D0-FFF8-DF50-98AF-16327F6D50C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8C2A3B-452D-6C76-F711-23101EC4C05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CB6F80-B508-274D-BB49-ED415FA695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203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D016D8FB-1E57-A716-9F8D-4026EEDD47D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4081106"/>
              </p:ext>
            </p:extLst>
          </p:nvPr>
        </p:nvGraphicFramePr>
        <p:xfrm>
          <a:off x="232892" y="1146811"/>
          <a:ext cx="11130327" cy="2628383"/>
        </p:xfrm>
        <a:graphic>
          <a:graphicData uri="http://schemas.openxmlformats.org/drawingml/2006/table">
            <a:tbl>
              <a:tblPr/>
              <a:tblGrid>
                <a:gridCol w="769133">
                  <a:extLst>
                    <a:ext uri="{9D8B030D-6E8A-4147-A177-3AD203B41FA5}">
                      <a16:colId xmlns:a16="http://schemas.microsoft.com/office/drawing/2014/main" val="216644085"/>
                    </a:ext>
                  </a:extLst>
                </a:gridCol>
                <a:gridCol w="769133">
                  <a:extLst>
                    <a:ext uri="{9D8B030D-6E8A-4147-A177-3AD203B41FA5}">
                      <a16:colId xmlns:a16="http://schemas.microsoft.com/office/drawing/2014/main" val="885022542"/>
                    </a:ext>
                  </a:extLst>
                </a:gridCol>
                <a:gridCol w="769133">
                  <a:extLst>
                    <a:ext uri="{9D8B030D-6E8A-4147-A177-3AD203B41FA5}">
                      <a16:colId xmlns:a16="http://schemas.microsoft.com/office/drawing/2014/main" val="3964792131"/>
                    </a:ext>
                  </a:extLst>
                </a:gridCol>
                <a:gridCol w="769133">
                  <a:extLst>
                    <a:ext uri="{9D8B030D-6E8A-4147-A177-3AD203B41FA5}">
                      <a16:colId xmlns:a16="http://schemas.microsoft.com/office/drawing/2014/main" val="1472416315"/>
                    </a:ext>
                  </a:extLst>
                </a:gridCol>
                <a:gridCol w="769133">
                  <a:extLst>
                    <a:ext uri="{9D8B030D-6E8A-4147-A177-3AD203B41FA5}">
                      <a16:colId xmlns:a16="http://schemas.microsoft.com/office/drawing/2014/main" val="2629990695"/>
                    </a:ext>
                  </a:extLst>
                </a:gridCol>
                <a:gridCol w="769133">
                  <a:extLst>
                    <a:ext uri="{9D8B030D-6E8A-4147-A177-3AD203B41FA5}">
                      <a16:colId xmlns:a16="http://schemas.microsoft.com/office/drawing/2014/main" val="2734177378"/>
                    </a:ext>
                  </a:extLst>
                </a:gridCol>
                <a:gridCol w="769133">
                  <a:extLst>
                    <a:ext uri="{9D8B030D-6E8A-4147-A177-3AD203B41FA5}">
                      <a16:colId xmlns:a16="http://schemas.microsoft.com/office/drawing/2014/main" val="2808909024"/>
                    </a:ext>
                  </a:extLst>
                </a:gridCol>
                <a:gridCol w="769133">
                  <a:extLst>
                    <a:ext uri="{9D8B030D-6E8A-4147-A177-3AD203B41FA5}">
                      <a16:colId xmlns:a16="http://schemas.microsoft.com/office/drawing/2014/main" val="2656848188"/>
                    </a:ext>
                  </a:extLst>
                </a:gridCol>
                <a:gridCol w="769133">
                  <a:extLst>
                    <a:ext uri="{9D8B030D-6E8A-4147-A177-3AD203B41FA5}">
                      <a16:colId xmlns:a16="http://schemas.microsoft.com/office/drawing/2014/main" val="1618273159"/>
                    </a:ext>
                  </a:extLst>
                </a:gridCol>
                <a:gridCol w="769133">
                  <a:extLst>
                    <a:ext uri="{9D8B030D-6E8A-4147-A177-3AD203B41FA5}">
                      <a16:colId xmlns:a16="http://schemas.microsoft.com/office/drawing/2014/main" val="1462318149"/>
                    </a:ext>
                  </a:extLst>
                </a:gridCol>
                <a:gridCol w="945945">
                  <a:extLst>
                    <a:ext uri="{9D8B030D-6E8A-4147-A177-3AD203B41FA5}">
                      <a16:colId xmlns:a16="http://schemas.microsoft.com/office/drawing/2014/main" val="764296938"/>
                    </a:ext>
                  </a:extLst>
                </a:gridCol>
                <a:gridCol w="954786">
                  <a:extLst>
                    <a:ext uri="{9D8B030D-6E8A-4147-A177-3AD203B41FA5}">
                      <a16:colId xmlns:a16="http://schemas.microsoft.com/office/drawing/2014/main" val="1488184423"/>
                    </a:ext>
                  </a:extLst>
                </a:gridCol>
                <a:gridCol w="769133">
                  <a:extLst>
                    <a:ext uri="{9D8B030D-6E8A-4147-A177-3AD203B41FA5}">
                      <a16:colId xmlns:a16="http://schemas.microsoft.com/office/drawing/2014/main" val="689498233"/>
                    </a:ext>
                  </a:extLst>
                </a:gridCol>
                <a:gridCol w="769133">
                  <a:extLst>
                    <a:ext uri="{9D8B030D-6E8A-4147-A177-3AD203B41FA5}">
                      <a16:colId xmlns:a16="http://schemas.microsoft.com/office/drawing/2014/main" val="3318238144"/>
                    </a:ext>
                  </a:extLst>
                </a:gridCol>
              </a:tblGrid>
              <a:tr h="339834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 Group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plogroup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PSH.G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PSH.H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r201644.A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r201644.C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WS484.B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WS484.A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Z2.F.1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Z2.F.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st134 E36 A+ A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st134 E36 A+ B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st130 B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st130 A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9487604"/>
                  </a:ext>
                </a:extLst>
              </a:tr>
              <a:tr h="176808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 B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PSH.G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07503121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D86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7380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D57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811934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76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9552524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D86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6761888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57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83538098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76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91987687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D86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491975196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D57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28880189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D76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5182909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47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01673777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D67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0618402"/>
                  </a:ext>
                </a:extLst>
              </a:tr>
              <a:tr h="176808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 A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PSH.H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9125315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C8C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811934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76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465262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D28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465262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D28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32282717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D76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50583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D28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577824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D28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359334934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D67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9747972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D37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793491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D37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50050275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D47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9952084"/>
                  </a:ext>
                </a:extLst>
              </a:tr>
              <a:tr h="176808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 B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r201644.A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.603909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CBC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.1527703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C6C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34883354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D76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73525814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76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23214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D08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41410121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D76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36542966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D76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9769982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BD18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65839310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D57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6771305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38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9977593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D37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52379238"/>
                  </a:ext>
                </a:extLst>
              </a:tr>
              <a:tr h="176808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 A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r201644.C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8778305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C8C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451703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CDD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.7211217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C3B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3944381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28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32282717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D76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3145554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28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3684756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D28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048696548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D67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76300638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D37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6493906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D37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2263765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D47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8632732"/>
                  </a:ext>
                </a:extLst>
              </a:tr>
              <a:tr h="176808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 A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WS484.B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.415691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C8C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.9983511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CFD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.137160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C6C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.9423904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0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82709087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D76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5062808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28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305871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28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748334741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D67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88366678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BD18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1074861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28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3783715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D37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371750"/>
                  </a:ext>
                </a:extLst>
              </a:tr>
              <a:tr h="176808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 B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WS484.A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5.6310844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CBC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.586473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C7C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.9672787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6E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7752974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C8C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0461514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C7C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42098373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D76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39284224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D76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47023775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BD18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64378417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D57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373673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38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402511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D37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3586698"/>
                  </a:ext>
                </a:extLst>
              </a:tr>
              <a:tr h="176808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 A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Z2.F.1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.8020301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C8C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.0416321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CFD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.8012003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C7C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.335824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1D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.1241276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1D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0325705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C7C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218389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28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973507303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D67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5638255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D37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08192495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D37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25456601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D47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14855410"/>
                  </a:ext>
                </a:extLst>
              </a:tr>
              <a:tr h="176808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 A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Z2.F.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.1130247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C8C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.296265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D0D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189646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C7C4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.9382004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0D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.277821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0DD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0325705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C7C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.1592265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1D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019244936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D67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61189026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D37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4473503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D37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26817834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D47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9237364"/>
                  </a:ext>
                </a:extLst>
              </a:tr>
              <a:tr h="339834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 A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st134E36.A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7280884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FCAC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.788191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C8C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.8716476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D2E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757776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9C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3.7768628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FCAC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.0996726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D2E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9317606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9C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8285565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9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18728618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D76E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0421897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D28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6053713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D37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3095061"/>
                  </a:ext>
                </a:extLst>
              </a:tr>
              <a:tr h="176808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 B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st134E36.B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.5349448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C8C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.8565507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D2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2738087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C9C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8161797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CED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.302844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1D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2.6208526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C9C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.352631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CED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.415563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CDD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.7211216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C3B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9447145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28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2693325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D37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6877065"/>
                  </a:ext>
                </a:extLst>
              </a:tr>
              <a:tr h="176808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 A</a:t>
                      </a:r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st130.1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.435820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B593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3733137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B69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1645186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B89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.5335426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B798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3091754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B89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.6711594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B99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.1376973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B7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.925344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B79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.4626883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B69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.92534416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B79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059626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D96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0053643"/>
                  </a:ext>
                </a:extLst>
              </a:tr>
              <a:tr h="176808"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 A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st130.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.2489396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C2B5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.077671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C2B7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.9333308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C5B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3854833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C4B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.2962745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C6B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.1835474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C5B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6682425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C4B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8404938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C4B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6.66824252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C4BC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84049379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C4BA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.8268027</a:t>
                      </a: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C4B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381" marR="8381" marT="838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4374943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E4BAAE60-D71E-5F9B-0BF6-DCD7A66FB092}"/>
              </a:ext>
            </a:extLst>
          </p:cNvPr>
          <p:cNvSpPr txBox="1"/>
          <p:nvPr/>
        </p:nvSpPr>
        <p:spPr>
          <a:xfrm rot="16200000">
            <a:off x="11258016" y="2191429"/>
            <a:ext cx="109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NPs/</a:t>
            </a:r>
            <a:r>
              <a:rPr lang="en-US" dirty="0" err="1"/>
              <a:t>Kbp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3415952-B938-ECC6-3C35-07B1432572F4}"/>
              </a:ext>
            </a:extLst>
          </p:cNvPr>
          <p:cNvSpPr txBox="1"/>
          <p:nvPr/>
        </p:nvSpPr>
        <p:spPr>
          <a:xfrm>
            <a:off x="4699656" y="3771364"/>
            <a:ext cx="27926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ercent alignment coverage</a:t>
            </a:r>
          </a:p>
        </p:txBody>
      </p:sp>
    </p:spTree>
    <p:extLst>
      <p:ext uri="{BB962C8B-B14F-4D97-AF65-F5344CB8AC3E}">
        <p14:creationId xmlns:p14="http://schemas.microsoft.com/office/powerpoint/2010/main" val="10493778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243</Words>
  <Application>Microsoft Macintosh PowerPoint</Application>
  <PresentationFormat>Widescreen</PresentationFormat>
  <Paragraphs>17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lden, Samuel</dc:creator>
  <cp:lastModifiedBy>Holden, Samuel</cp:lastModifiedBy>
  <cp:revision>8</cp:revision>
  <dcterms:created xsi:type="dcterms:W3CDTF">2025-03-28T20:18:18Z</dcterms:created>
  <dcterms:modified xsi:type="dcterms:W3CDTF">2025-10-23T21:26:15Z</dcterms:modified>
</cp:coreProperties>
</file>